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501" y="48"/>
      </p:cViewPr>
      <p:guideLst>
        <p:guide orient="horz" pos="31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3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81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5760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938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59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700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0318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005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196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43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8870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2BCF9-E21E-4A59-89A9-04EA4039B66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58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CuadroTexto 164">
            <a:extLst>
              <a:ext uri="{FF2B5EF4-FFF2-40B4-BE49-F238E27FC236}">
                <a16:creationId xmlns:a16="http://schemas.microsoft.com/office/drawing/2014/main" id="{67340645-146F-070B-B12B-B97A737255CB}"/>
              </a:ext>
            </a:extLst>
          </p:cNvPr>
          <p:cNvSpPr txBox="1"/>
          <p:nvPr/>
        </p:nvSpPr>
        <p:spPr>
          <a:xfrm>
            <a:off x="472575" y="379725"/>
            <a:ext cx="5965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4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for the selection of NK and NKT cells and analysis of cytokine expression in PBMCs of study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Imagen 35">
            <a:extLst>
              <a:ext uri="{FF2B5EF4-FFF2-40B4-BE49-F238E27FC236}">
                <a16:creationId xmlns:a16="http://schemas.microsoft.com/office/drawing/2014/main" id="{5F8F9494-451E-B04B-907A-D4B77F9D91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40" y="1142945"/>
            <a:ext cx="6639119" cy="7675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3551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25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18</cp:revision>
  <dcterms:created xsi:type="dcterms:W3CDTF">2025-10-23T08:08:58Z</dcterms:created>
  <dcterms:modified xsi:type="dcterms:W3CDTF">2025-11-04T06:1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1-04T06:10:30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ae605ad1-d1b4-4914-bece-6dd68d791e53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